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58" y="-3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\\Rixdsntp001\rdpub_doc\Publications%20in%20Preparation\T-Bac%20publication%20A.%20Ferraro\6.%20Figures%20&amp;%20data%20from%20AF\other%20data\Fig%20S1_13-00102182-A2%23memory%20and%20naive%20prolif%20to%20Staph%20Ags.xls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paper figures'!$B$11</c:f>
              <c:strCache>
                <c:ptCount val="1"/>
                <c:pt idx="0">
                  <c:v>Memory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 w="12700">
              <a:solidFill>
                <a:sysClr val="windowText" lastClr="000000"/>
              </a:solidFill>
            </a:ln>
          </c:spPr>
          <c:invertIfNegative val="0"/>
          <c:cat>
            <c:multiLvlStrRef>
              <c:f>'paper figures'!$C$9:$F$10</c:f>
              <c:multiLvlStrCache>
                <c:ptCount val="4"/>
                <c:lvl>
                  <c:pt idx="0">
                    <c:v>TRAP</c:v>
                  </c:pt>
                  <c:pt idx="1">
                    <c:v>KWC</c:v>
                  </c:pt>
                  <c:pt idx="2">
                    <c:v>TRAP</c:v>
                  </c:pt>
                  <c:pt idx="3">
                    <c:v>KWC</c:v>
                  </c:pt>
                </c:lvl>
                <c:lvl>
                  <c:pt idx="0">
                    <c:v>7 Days</c:v>
                  </c:pt>
                  <c:pt idx="2">
                    <c:v>14 Days</c:v>
                  </c:pt>
                </c:lvl>
              </c:multiLvlStrCache>
            </c:multiLvlStrRef>
          </c:cat>
          <c:val>
            <c:numRef>
              <c:f>'paper figures'!$C$11:$F$11</c:f>
              <c:numCache>
                <c:formatCode>General</c:formatCode>
                <c:ptCount val="4"/>
                <c:pt idx="0">
                  <c:v>0</c:v>
                </c:pt>
                <c:pt idx="1">
                  <c:v>18.329999999999998</c:v>
                </c:pt>
                <c:pt idx="2">
                  <c:v>0</c:v>
                </c:pt>
                <c:pt idx="3">
                  <c:v>7.7</c:v>
                </c:pt>
              </c:numCache>
            </c:numRef>
          </c:val>
        </c:ser>
        <c:ser>
          <c:idx val="1"/>
          <c:order val="1"/>
          <c:tx>
            <c:strRef>
              <c:f>'paper figures'!$B$12</c:f>
              <c:strCache>
                <c:ptCount val="1"/>
                <c:pt idx="0">
                  <c:v>Naïve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 w="12700">
              <a:solidFill>
                <a:sysClr val="windowText" lastClr="000000"/>
              </a:solidFill>
            </a:ln>
          </c:spPr>
          <c:invertIfNegative val="0"/>
          <c:cat>
            <c:multiLvlStrRef>
              <c:f>'paper figures'!$C$9:$F$10</c:f>
              <c:multiLvlStrCache>
                <c:ptCount val="4"/>
                <c:lvl>
                  <c:pt idx="0">
                    <c:v>TRAP</c:v>
                  </c:pt>
                  <c:pt idx="1">
                    <c:v>KWC</c:v>
                  </c:pt>
                  <c:pt idx="2">
                    <c:v>TRAP</c:v>
                  </c:pt>
                  <c:pt idx="3">
                    <c:v>KWC</c:v>
                  </c:pt>
                </c:lvl>
                <c:lvl>
                  <c:pt idx="0">
                    <c:v>7 Days</c:v>
                  </c:pt>
                  <c:pt idx="2">
                    <c:v>14 Days</c:v>
                  </c:pt>
                </c:lvl>
              </c:multiLvlStrCache>
            </c:multiLvlStrRef>
          </c:cat>
          <c:val>
            <c:numRef>
              <c:f>'paper figures'!$C$12:$F$12</c:f>
              <c:numCache>
                <c:formatCode>General</c:formatCode>
                <c:ptCount val="4"/>
                <c:pt idx="0">
                  <c:v>0</c:v>
                </c:pt>
                <c:pt idx="1">
                  <c:v>8.0000000000000016E-2</c:v>
                </c:pt>
                <c:pt idx="2">
                  <c:v>0</c:v>
                </c:pt>
                <c:pt idx="3">
                  <c:v>0.9000000000000001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7632512"/>
        <c:axId val="87962752"/>
      </c:barChart>
      <c:catAx>
        <c:axId val="876325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1200" b="0" i="0" baseline="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87962752"/>
        <c:crosses val="autoZero"/>
        <c:auto val="1"/>
        <c:lblAlgn val="ctr"/>
        <c:lblOffset val="100"/>
        <c:noMultiLvlLbl val="0"/>
      </c:catAx>
      <c:valAx>
        <c:axId val="879627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87632512"/>
        <c:crosses val="autoZero"/>
        <c:crossBetween val="between"/>
      </c:valAx>
      <c:spPr>
        <a:ln>
          <a:noFill/>
        </a:ln>
      </c:spPr>
    </c:plotArea>
    <c:legend>
      <c:legendPos val="r"/>
      <c:layout>
        <c:manualLayout>
          <c:xMode val="edge"/>
          <c:yMode val="edge"/>
          <c:x val="0.46386041431904385"/>
          <c:y val="0.11159283149547257"/>
          <c:w val="0.29474015748031496"/>
          <c:h val="0.18062207479599257"/>
        </c:manualLayout>
      </c:layout>
      <c:overlay val="0"/>
      <c:txPr>
        <a:bodyPr/>
        <a:lstStyle/>
        <a:p>
          <a:pPr>
            <a:defRPr sz="1400" b="0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ln w="12700">
      <a:noFill/>
    </a:ln>
  </c:sp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fr-B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fr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6DD3D-16FA-4A53-AE91-ECB7135D4205}" type="datetimeFigureOut">
              <a:rPr lang="fr-BE" smtClean="0"/>
              <a:t>24/07/2018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5317E-4A87-4183-8D5E-8E0EBC95AB8C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2771890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B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6DD3D-16FA-4A53-AE91-ECB7135D4205}" type="datetimeFigureOut">
              <a:rPr lang="fr-BE" smtClean="0"/>
              <a:t>24/07/2018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5317E-4A87-4183-8D5E-8E0EBC95AB8C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7700443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fr-B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6DD3D-16FA-4A53-AE91-ECB7135D4205}" type="datetimeFigureOut">
              <a:rPr lang="fr-BE" smtClean="0"/>
              <a:t>24/07/2018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5317E-4A87-4183-8D5E-8E0EBC95AB8C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40829454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B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6DD3D-16FA-4A53-AE91-ECB7135D4205}" type="datetimeFigureOut">
              <a:rPr lang="fr-BE" smtClean="0"/>
              <a:t>24/07/2018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5317E-4A87-4183-8D5E-8E0EBC95AB8C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4335074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fr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6DD3D-16FA-4A53-AE91-ECB7135D4205}" type="datetimeFigureOut">
              <a:rPr lang="fr-BE" smtClean="0"/>
              <a:t>24/07/2018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5317E-4A87-4183-8D5E-8E0EBC95AB8C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1188065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B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B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B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6DD3D-16FA-4A53-AE91-ECB7135D4205}" type="datetimeFigureOut">
              <a:rPr lang="fr-BE" smtClean="0"/>
              <a:t>24/07/2018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5317E-4A87-4183-8D5E-8E0EBC95AB8C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42565942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fr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B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B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6DD3D-16FA-4A53-AE91-ECB7135D4205}" type="datetimeFigureOut">
              <a:rPr lang="fr-BE" smtClean="0"/>
              <a:t>24/07/2018</a:t>
            </a:fld>
            <a:endParaRPr lang="fr-B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5317E-4A87-4183-8D5E-8E0EBC95AB8C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8984457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B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6DD3D-16FA-4A53-AE91-ECB7135D4205}" type="datetimeFigureOut">
              <a:rPr lang="fr-BE" smtClean="0"/>
              <a:t>24/07/2018</a:t>
            </a:fld>
            <a:endParaRPr lang="fr-B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5317E-4A87-4183-8D5E-8E0EBC95AB8C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3158771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6DD3D-16FA-4A53-AE91-ECB7135D4205}" type="datetimeFigureOut">
              <a:rPr lang="fr-BE" smtClean="0"/>
              <a:t>24/07/2018</a:t>
            </a:fld>
            <a:endParaRPr lang="fr-B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5317E-4A87-4183-8D5E-8E0EBC95AB8C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9540448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fr-B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B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6DD3D-16FA-4A53-AE91-ECB7135D4205}" type="datetimeFigureOut">
              <a:rPr lang="fr-BE" smtClean="0"/>
              <a:t>24/07/2018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5317E-4A87-4183-8D5E-8E0EBC95AB8C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3129817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fr-B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B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6DD3D-16FA-4A53-AE91-ECB7135D4205}" type="datetimeFigureOut">
              <a:rPr lang="fr-BE" smtClean="0"/>
              <a:t>24/07/2018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5317E-4A87-4183-8D5E-8E0EBC95AB8C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530757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fr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D6DD3D-16FA-4A53-AE91-ECB7135D4205}" type="datetimeFigureOut">
              <a:rPr lang="fr-BE" smtClean="0"/>
              <a:t>24/07/2018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C5317E-4A87-4183-8D5E-8E0EBC95AB8C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6200240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826078" y="107504"/>
            <a:ext cx="4752528" cy="5872114"/>
            <a:chOff x="251520" y="-27384"/>
            <a:chExt cx="4752528" cy="5872114"/>
          </a:xfrm>
        </p:grpSpPr>
        <p:graphicFrame>
          <p:nvGraphicFramePr>
            <p:cNvPr id="12" name="Chart 1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9324929"/>
                </p:ext>
              </p:extLst>
            </p:nvPr>
          </p:nvGraphicFramePr>
          <p:xfrm>
            <a:off x="971600" y="2836069"/>
            <a:ext cx="4032448" cy="300866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3" name="TextBox 2"/>
            <p:cNvSpPr txBox="1"/>
            <p:nvPr/>
          </p:nvSpPr>
          <p:spPr>
            <a:xfrm rot="16200000">
              <a:off x="-620167" y="3940648"/>
              <a:ext cx="2863453" cy="255981"/>
            </a:xfrm>
            <a:prstGeom prst="rect">
              <a:avLst/>
            </a:prstGeom>
            <a:solidFill>
              <a:schemeClr val="lt1"/>
            </a:solidFill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BE" sz="1400" dirty="0">
                  <a:latin typeface="Arial" panose="020B0604020202020204" pitchFamily="34" charset="0"/>
                  <a:cs typeface="Arial" panose="020B0604020202020204" pitchFamily="34" charset="0"/>
                </a:rPr>
                <a:t>% of </a:t>
              </a:r>
              <a:r>
                <a:rPr lang="fr-B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proliferating</a:t>
              </a:r>
              <a:r>
                <a:rPr lang="fr-BE" sz="1400" dirty="0">
                  <a:latin typeface="Arial" panose="020B0604020202020204" pitchFamily="34" charset="0"/>
                  <a:cs typeface="Arial" panose="020B0604020202020204" pitchFamily="34" charset="0"/>
                </a:rPr>
                <a:t> CD4</a:t>
              </a:r>
              <a:r>
                <a:rPr lang="fr-BE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fr-BE" sz="1400" dirty="0">
                  <a:latin typeface="Arial" panose="020B0604020202020204" pitchFamily="34" charset="0"/>
                  <a:cs typeface="Arial" panose="020B0604020202020204" pitchFamily="34" charset="0"/>
                </a:rPr>
                <a:t> T </a:t>
              </a:r>
              <a:r>
                <a:rPr lang="fr-B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  <a:r>
                <a:rPr lang="fr-BE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51520" y="2492896"/>
              <a:ext cx="56003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fr-BE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51520" y="-27384"/>
              <a:ext cx="68803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fr-BE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6" name="Picture 15"/>
            <p:cNvPicPr/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620" t="16065"/>
            <a:stretch/>
          </p:blipFill>
          <p:spPr>
            <a:xfrm>
              <a:off x="552955" y="260648"/>
              <a:ext cx="3814758" cy="2478833"/>
            </a:xfrm>
            <a:prstGeom prst="rect">
              <a:avLst/>
            </a:prstGeom>
          </p:spPr>
        </p:pic>
      </p:grpSp>
      <p:sp>
        <p:nvSpPr>
          <p:cNvPr id="3" name="TextBox 2"/>
          <p:cNvSpPr txBox="1"/>
          <p:nvPr/>
        </p:nvSpPr>
        <p:spPr>
          <a:xfrm>
            <a:off x="260648" y="6300192"/>
            <a:ext cx="6336704" cy="26010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	SA-specific memory responses in healthy subjects</a:t>
            </a:r>
            <a:r>
              <a:rPr lang="en-US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Trace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labelled naïve (CD3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5RA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memory (CD3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5RA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D4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were cultured with (CD14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nocytes that were either pulsed with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phylococcus aureus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SA) killed whole-cell antigen (KWC) or malaria thrombospondin-related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onymus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in (TRAP; control antigen), or left non-pulsed (no Ag, medium only), for 7 and 14 days to detect memory and naïve responses, respectively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gating strategy to identify the specific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mory T cells at day 7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using flow cytometry, is presented. The numbers in the plots (pink and black: actual and rounded values respectively) denominate each distinct population based on the percentage of proliferating cells in the CD4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-cell population.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ckground (medium)-subtracted frequencies of proliferating cells in CD4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 cells are represented. Data in (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(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re derived from the same donor of the two donors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sted.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12902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GlaxoSmithKline Biological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len Oe</dc:creator>
  <cp:lastModifiedBy>Ellen Oe</cp:lastModifiedBy>
  <cp:revision>4</cp:revision>
  <dcterms:created xsi:type="dcterms:W3CDTF">2016-05-31T12:25:25Z</dcterms:created>
  <dcterms:modified xsi:type="dcterms:W3CDTF">2018-07-24T08:53:12Z</dcterms:modified>
</cp:coreProperties>
</file>